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1" r:id="rId2"/>
    <p:sldId id="262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7" d="100"/>
          <a:sy n="57" d="100"/>
        </p:scale>
        <p:origin x="2587" y="67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668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486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825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726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835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133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4262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563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10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33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970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593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496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270" y="5034841"/>
            <a:ext cx="6592925" cy="2530665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574" y="2545486"/>
            <a:ext cx="6592925" cy="2550271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9270" y="42085"/>
            <a:ext cx="6592925" cy="2541221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2193523" y="-43549"/>
            <a:ext cx="180068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2400" b="1" dirty="0"/>
              <a:t>a</a:t>
            </a:r>
            <a:r>
              <a:rPr lang="en-IN" sz="2400" b="1" dirty="0" smtClean="0"/>
              <a:t>. GMRQ517</a:t>
            </a:r>
            <a:endParaRPr lang="en-IN" sz="2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2250363" y="2472386"/>
            <a:ext cx="18135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  <a:r>
              <a:rPr lang="en-US" sz="2400" b="1" dirty="0" smtClean="0"/>
              <a:t>. GMRQ786</a:t>
            </a:r>
            <a:endParaRPr lang="en-US" sz="2400" dirty="0"/>
          </a:p>
        </p:txBody>
      </p:sp>
      <p:sp>
        <p:nvSpPr>
          <p:cNvPr id="18" name="TextBox 17"/>
          <p:cNvSpPr txBox="1"/>
          <p:nvPr/>
        </p:nvSpPr>
        <p:spPr>
          <a:xfrm>
            <a:off x="2193523" y="4938024"/>
            <a:ext cx="18455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 c. GMRQ843</a:t>
            </a:r>
            <a:endParaRPr lang="en-US" sz="2400" b="1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9270" y="7468661"/>
            <a:ext cx="6490229" cy="2488700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2473172" y="7425765"/>
            <a:ext cx="17550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2400" b="1" dirty="0" smtClean="0"/>
              <a:t>d. GMLQ975</a:t>
            </a:r>
            <a:endParaRPr lang="en-IN" sz="2400" b="1" dirty="0"/>
          </a:p>
        </p:txBody>
      </p:sp>
    </p:spTree>
    <p:extLst>
      <p:ext uri="{BB962C8B-B14F-4D97-AF65-F5344CB8AC3E}">
        <p14:creationId xmlns:p14="http://schemas.microsoft.com/office/powerpoint/2010/main" val="29194301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89112" y="228600"/>
            <a:ext cx="6407524" cy="7294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2. Validation of four identified diagnostic markers in a set of germplasm for rust and late leaf spot resistance.</a:t>
            </a:r>
            <a:endParaRPr lang="en-US" sz="1600" dirty="0">
              <a:effectLst/>
              <a:latin typeface="Calibri" panose="020F0502020204030204" pitchFamily="34" charset="0"/>
              <a:ea typeface="MS Mincho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2328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53</TotalTime>
  <Words>35</Words>
  <Application>Microsoft Office PowerPoint</Application>
  <PresentationFormat>A4 Paper (210x297 mm)</PresentationFormat>
  <Paragraphs>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ngh, Vikas (ICRISAT-IN)</dc:creator>
  <cp:lastModifiedBy>Pandey</cp:lastModifiedBy>
  <cp:revision>96</cp:revision>
  <dcterms:created xsi:type="dcterms:W3CDTF">2015-04-20T11:32:42Z</dcterms:created>
  <dcterms:modified xsi:type="dcterms:W3CDTF">2016-09-26T10:51:01Z</dcterms:modified>
</cp:coreProperties>
</file>